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5" autoAdjust="0"/>
    <p:restoredTop sz="94660"/>
  </p:normalViewPr>
  <p:slideViewPr>
    <p:cSldViewPr snapToGrid="0">
      <p:cViewPr varScale="1">
        <p:scale>
          <a:sx n="54" d="100"/>
          <a:sy n="54" d="100"/>
        </p:scale>
        <p:origin x="206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2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441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017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899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435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7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78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57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759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130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04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8FCA9-49FD-442F-B1E0-B399B198C281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9CCEC-4295-4E97-A598-71A89A8BD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74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4582" b="5941"/>
          <a:stretch/>
        </p:blipFill>
        <p:spPr>
          <a:xfrm>
            <a:off x="1816769" y="745104"/>
            <a:ext cx="3583101" cy="245026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77746" y="3186954"/>
            <a:ext cx="27045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2 transformed mean expression level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673847" y="1635091"/>
            <a:ext cx="2056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2 transformed fold chang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7819"/>
            <a:ext cx="2392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8" name="Rectangle 7"/>
          <p:cNvSpPr/>
          <p:nvPr/>
        </p:nvSpPr>
        <p:spPr>
          <a:xfrm>
            <a:off x="554902" y="7553045"/>
            <a:ext cx="60547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.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 plot of DEGs. X axis represents value A (log2 transformed mean expression level). Y axis represents value M (log2 transformed fold change). Red dots represent up-regulated DEGs. Blue dots represent down-regulated DEGs. Gray points represent non-DEGs. (B) Pathway classification of DEGs. X axis represents number of DEG. Y axis represents functional classification of KEGG. There are seven branches for KEGG pathways: Cellular Processes, Environmental Information Processing, Genetic Information Processing, Human Disease, Metabolism, Organismal Systems and Drug Development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EA815BF-B4E8-4DD7-8BF3-61609A5A34E2}"/>
              </a:ext>
            </a:extLst>
          </p:cNvPr>
          <p:cNvGrpSpPr/>
          <p:nvPr/>
        </p:nvGrpSpPr>
        <p:grpSpPr>
          <a:xfrm>
            <a:off x="1437433" y="3860261"/>
            <a:ext cx="3577718" cy="3553919"/>
            <a:chOff x="377138" y="993632"/>
            <a:chExt cx="3577718" cy="3553919"/>
          </a:xfrm>
        </p:grpSpPr>
        <p:pic>
          <p:nvPicPr>
            <p:cNvPr id="14" name="Picture 13" descr="C-VS-S.DEseq2_Method.KEGG.pdf - Adobe Acrobat Reader DC">
              <a:extLst>
                <a:ext uri="{FF2B5EF4-FFF2-40B4-BE49-F238E27FC236}">
                  <a16:creationId xmlns:a16="http://schemas.microsoft.com/office/drawing/2014/main" id="{088D7CEA-38F4-4D9F-819B-434B09DE1C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90" t="20022" r="50385" b="1919"/>
            <a:stretch/>
          </p:blipFill>
          <p:spPr>
            <a:xfrm>
              <a:off x="377138" y="1156193"/>
              <a:ext cx="2855277" cy="3391358"/>
            </a:xfrm>
            <a:prstGeom prst="rect">
              <a:avLst/>
            </a:prstGeom>
          </p:spPr>
        </p:pic>
        <p:pic>
          <p:nvPicPr>
            <p:cNvPr id="15" name="Picture 14" descr="C-VS-S.DEseq2_Method.KEGG.pdf - Adobe Acrobat Reader DC">
              <a:extLst>
                <a:ext uri="{FF2B5EF4-FFF2-40B4-BE49-F238E27FC236}">
                  <a16:creationId xmlns:a16="http://schemas.microsoft.com/office/drawing/2014/main" id="{92D72E67-F8EA-4F6E-8D16-F5DC25B646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06" t="50460" r="32943" b="35839"/>
            <a:stretch/>
          </p:blipFill>
          <p:spPr>
            <a:xfrm>
              <a:off x="2673166" y="2896562"/>
              <a:ext cx="1281690" cy="54226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6D82BB0-8251-408D-AA28-6DC3612E754E}"/>
                </a:ext>
              </a:extLst>
            </p:cNvPr>
            <p:cNvSpPr txBox="1"/>
            <p:nvPr/>
          </p:nvSpPr>
          <p:spPr>
            <a:xfrm>
              <a:off x="2034806" y="993632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KEGG Pathway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554901" y="376461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55489" y="367559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534474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</TotalTime>
  <Words>125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g Chris K C</dc:creator>
  <cp:lastModifiedBy>SATHISH</cp:lastModifiedBy>
  <cp:revision>15</cp:revision>
  <dcterms:created xsi:type="dcterms:W3CDTF">2019-07-29T08:48:58Z</dcterms:created>
  <dcterms:modified xsi:type="dcterms:W3CDTF">2020-10-28T09:25:34Z</dcterms:modified>
</cp:coreProperties>
</file>